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pos="346">
          <p15:clr>
            <a:srgbClr val="A4A3A4"/>
          </p15:clr>
        </p15:guide>
        <p15:guide id="4" pos="3974">
          <p15:clr>
            <a:srgbClr val="A4A3A4"/>
          </p15:clr>
        </p15:guide>
        <p15:guide id="5" pos="981" userDrawn="1">
          <p15:clr>
            <a:srgbClr val="A4A3A4"/>
          </p15:clr>
        </p15:guide>
        <p15:guide id="6" pos="30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543" autoAdjust="0"/>
  </p:normalViewPr>
  <p:slideViewPr>
    <p:cSldViewPr>
      <p:cViewPr>
        <p:scale>
          <a:sx n="150" d="100"/>
          <a:sy n="150" d="100"/>
        </p:scale>
        <p:origin x="1470" y="-3666"/>
      </p:cViewPr>
      <p:guideLst>
        <p:guide orient="horz" pos="2880"/>
        <p:guide pos="2160"/>
        <p:guide pos="346"/>
        <p:guide pos="3974"/>
        <p:guide pos="981"/>
        <p:guide pos="30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2438DE-8419-4D34-AF93-B184B0438E9E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A3CAC7-8219-418F-A48C-BC23BAC53B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232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6E36EB-3B18-4FB1-83D8-889709389EB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82475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A3CAC7-8219-418F-A48C-BC23BAC53B33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8516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meme-suite.org/tools/meme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123" b="58397"/>
          <a:stretch/>
        </p:blipFill>
        <p:spPr bwMode="auto">
          <a:xfrm>
            <a:off x="548680" y="889750"/>
            <a:ext cx="5760000" cy="5914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矩形 9"/>
          <p:cNvSpPr/>
          <p:nvPr/>
        </p:nvSpPr>
        <p:spPr>
          <a:xfrm>
            <a:off x="2122120" y="827584"/>
            <a:ext cx="802824" cy="604867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3789040" y="827584"/>
            <a:ext cx="774000" cy="604867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矩形 1"/>
          <p:cNvSpPr/>
          <p:nvPr/>
        </p:nvSpPr>
        <p:spPr>
          <a:xfrm>
            <a:off x="2124869" y="719001"/>
            <a:ext cx="792000" cy="72008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2132856" y="531245"/>
            <a:ext cx="864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iR159.1-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789040" y="719001"/>
            <a:ext cx="774000" cy="7200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3753607" y="531245"/>
            <a:ext cx="864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iR159.2-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3529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603" r="31123" b="16794"/>
          <a:stretch/>
        </p:blipFill>
        <p:spPr bwMode="auto">
          <a:xfrm>
            <a:off x="573583" y="643246"/>
            <a:ext cx="5760000" cy="5914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矩形 9"/>
          <p:cNvSpPr/>
          <p:nvPr/>
        </p:nvSpPr>
        <p:spPr>
          <a:xfrm>
            <a:off x="2708920" y="731756"/>
            <a:ext cx="702000" cy="604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4523750" y="731756"/>
            <a:ext cx="630000" cy="604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TextBox 21"/>
          <p:cNvSpPr txBox="1"/>
          <p:nvPr/>
        </p:nvSpPr>
        <p:spPr>
          <a:xfrm>
            <a:off x="531195" y="7524328"/>
            <a:ext cx="57594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ation profile of fold back sequences of all the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159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ith sibling mature miRNA sequences marked in box. Conservation logos made by MEME (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://meme-suite.org/tools/meme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 included below with sibling mature miRNA sequences marked in box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4523750" y="607242"/>
            <a:ext cx="630000" cy="72008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TextBox 12"/>
          <p:cNvSpPr txBox="1"/>
          <p:nvPr/>
        </p:nvSpPr>
        <p:spPr>
          <a:xfrm>
            <a:off x="4437112" y="408496"/>
            <a:ext cx="864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iR159.1-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709149" y="610302"/>
            <a:ext cx="702000" cy="7200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2654968" y="408496"/>
            <a:ext cx="864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iR159.2-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7774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29</TotalTime>
  <Words>57</Words>
  <Application>Microsoft Office PowerPoint</Application>
  <PresentationFormat>On-screen Show (4:3)</PresentationFormat>
  <Paragraphs>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fliu</dc:creator>
  <cp:lastModifiedBy>M</cp:lastModifiedBy>
  <cp:revision>62</cp:revision>
  <dcterms:created xsi:type="dcterms:W3CDTF">2016-01-21T06:57:48Z</dcterms:created>
  <dcterms:modified xsi:type="dcterms:W3CDTF">2022-05-19T07:45:37Z</dcterms:modified>
</cp:coreProperties>
</file>